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533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025" autoAdjust="0"/>
    <p:restoredTop sz="94660"/>
  </p:normalViewPr>
  <p:slideViewPr>
    <p:cSldViewPr snapToGrid="0">
      <p:cViewPr varScale="1">
        <p:scale>
          <a:sx n="105" d="100"/>
          <a:sy n="105" d="100"/>
        </p:scale>
        <p:origin x="120" y="21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6591B6E-DD85-76F5-572D-5B283F611AE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90F97B54-B01C-F307-92B0-45FE54A302C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C0C5D81-BE07-67FC-2412-361DF9F95F3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BA27EE-F167-4B03-8720-DBDD29C2FEE8}" type="datetimeFigureOut">
              <a:rPr lang="en-US" smtClean="0"/>
              <a:t>2/9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0616F01-3548-29AB-F0F8-9A1FDDCF77F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636AA3C-E054-AC18-C6A8-97E162B4A07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890644-F2DF-49A8-B3CD-1C0DB78E0B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6965020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2E470E5-35EB-A23A-2079-BB9871CDAF1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C6362F4-D07B-1E1F-0961-5B36A78C19D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C1DB674-5B17-DD21-E71E-1E23E6FCC60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BA27EE-F167-4B03-8720-DBDD29C2FEE8}" type="datetimeFigureOut">
              <a:rPr lang="en-US" smtClean="0"/>
              <a:t>2/9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00775AD-5139-1CC2-AEEE-C7274F615BB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1FB8E08-27DA-4AF6-1F0A-387854ACBB2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890644-F2DF-49A8-B3CD-1C0DB78E0B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685228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0FCE7323-38EA-D133-4522-CAB0A60EF48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6B51A9B-4906-BAC8-5169-9C71FC2EB9D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CCF110F-2C3C-8FC7-F4F8-A43226068B9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BA27EE-F167-4B03-8720-DBDD29C2FEE8}" type="datetimeFigureOut">
              <a:rPr lang="en-US" smtClean="0"/>
              <a:t>2/9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C4BA0F0-1AAC-1D6D-E001-A5A21194D6D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08FF68D-5A61-9352-0335-87C1A6761C2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890644-F2DF-49A8-B3CD-1C0DB78E0B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0132938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814FF59-D2FC-1A00-53D8-76A301DF1E0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B05ED88-C146-71E4-D52B-8A82D42D179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F1300F5-F703-297B-FF23-5DC3EE62AA6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BA27EE-F167-4B03-8720-DBDD29C2FEE8}" type="datetimeFigureOut">
              <a:rPr lang="en-US" smtClean="0"/>
              <a:t>2/9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7C5522F-2E8A-C27A-513D-EF13B12F34C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EE3E46C-71B7-3B86-1E1F-BF18FC584CB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890644-F2DF-49A8-B3CD-1C0DB78E0B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7041742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D67590A-469A-54E1-15FE-C4DB0324F49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A44BB84-F999-7B0C-2227-43FAD38FF36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CEFFED6-3544-5224-8696-91BA07BBB3F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BA27EE-F167-4B03-8720-DBDD29C2FEE8}" type="datetimeFigureOut">
              <a:rPr lang="en-US" smtClean="0"/>
              <a:t>2/9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81C4F66-8158-9CBB-61FA-EB7B13DC402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D998BF8-2F7C-E9EE-6DF9-2EF54F1E9D9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890644-F2DF-49A8-B3CD-1C0DB78E0B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8801227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53A97D0-45D6-CD76-511D-A234E848071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D0BC010-D56B-1D68-89FA-062F874BA8A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A27F600-0533-19EE-47B9-C4BA6369C74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72539F1-605E-EE35-73DD-09D18ED8AAA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BA27EE-F167-4B03-8720-DBDD29C2FEE8}" type="datetimeFigureOut">
              <a:rPr lang="en-US" smtClean="0"/>
              <a:t>2/9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4119D70-99CF-51DB-CE9D-9C8C7E56463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8DA7AC8-40BF-3057-C590-18BE2C4128B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890644-F2DF-49A8-B3CD-1C0DB78E0B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108753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A213718-4BA8-D322-FF13-98AA9A9E54B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5535FE9-5C4B-17D7-BB59-A961C5EE7FA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16250D9-6D6A-E6E5-471C-8002643ECCB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6943EF32-884B-EF2E-0979-42C0118DCE3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37354C19-30FA-41EB-3C5C-6E4EED48544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5B429C22-7D79-733B-9F9F-4EFE47ABFFE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BA27EE-F167-4B03-8720-DBDD29C2FEE8}" type="datetimeFigureOut">
              <a:rPr lang="en-US" smtClean="0"/>
              <a:t>2/9/20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4661135C-861B-AED4-E692-8020D4785C6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ABFCED44-FC99-C913-0FA5-85F87B8B5AE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890644-F2DF-49A8-B3CD-1C0DB78E0B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1377043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06654DB-71D3-C547-4BA8-E0F93B3AEB3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7DDD4700-575A-9FB4-51DF-AFADC4602C9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BA27EE-F167-4B03-8720-DBDD29C2FEE8}" type="datetimeFigureOut">
              <a:rPr lang="en-US" smtClean="0"/>
              <a:t>2/9/20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FF4AFD67-5E06-90F9-5329-47574129B65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BDBEF4F3-6800-CE73-182B-2858396C343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890644-F2DF-49A8-B3CD-1C0DB78E0B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514384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CE581F51-4A85-AF76-7BC1-DE09A2DB2B9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BA27EE-F167-4B03-8720-DBDD29C2FEE8}" type="datetimeFigureOut">
              <a:rPr lang="en-US" smtClean="0"/>
              <a:t>2/9/20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49EE7159-7E52-C584-D711-53A768BDD4B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65CD1CC9-67EB-96A5-E90C-762130DFEE2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890644-F2DF-49A8-B3CD-1C0DB78E0B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1600737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0D631AF-32FB-F978-CD96-50E0B0E0417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AB1ED3B-01F5-CC44-95B6-1A15E1BC4CC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25EE9F9-6317-FC5F-538C-3ADF09AA735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C8B52E2-379D-08BB-4BD0-66F920E03D8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BA27EE-F167-4B03-8720-DBDD29C2FEE8}" type="datetimeFigureOut">
              <a:rPr lang="en-US" smtClean="0"/>
              <a:t>2/9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614F40B-2543-765E-DC0B-F82B19D46B4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722EB29-FC5F-C9FD-F09E-97A2D04FDE9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890644-F2DF-49A8-B3CD-1C0DB78E0B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8116818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8874128-E041-D9EA-D695-63D135E5714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9BFCE3E4-9E9A-02F4-7967-ACFB507F9EF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C12CA2C-E588-0949-E3D4-B06EC90D33C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E2FB69B-B3DA-0F22-B4F0-0976230EC2E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BA27EE-F167-4B03-8720-DBDD29C2FEE8}" type="datetimeFigureOut">
              <a:rPr lang="en-US" smtClean="0"/>
              <a:t>2/9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CBE11B9-7675-7A9A-A892-97CA47F4E1A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92ADA8A-C690-6BC5-238F-81BF6D77D43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890644-F2DF-49A8-B3CD-1C0DB78E0B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8487294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BA288017-75BD-C380-5C1F-6C0260E0AEF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344FACF-2A33-D139-4804-40BB926BD7B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35004FB-6988-09C4-218D-923AC21E201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CBA27EE-F167-4B03-8720-DBDD29C2FEE8}" type="datetimeFigureOut">
              <a:rPr lang="en-US" smtClean="0"/>
              <a:t>2/9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F9BBA40-421C-259A-884B-22367F06A1F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A740E4E-11A4-F140-7277-1E982CA26FA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A890644-F2DF-49A8-B3CD-1C0DB78E0BE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0536494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4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" name="Title 1">
            <a:extLst>
              <a:ext uri="{FF2B5EF4-FFF2-40B4-BE49-F238E27FC236}">
                <a16:creationId xmlns:a16="http://schemas.microsoft.com/office/drawing/2014/main" id="{3051DE51-3354-58B5-E19C-1459CB1A279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283426" y="844657"/>
            <a:ext cx="3124200" cy="768731"/>
          </a:xfrm>
        </p:spPr>
        <p:txBody>
          <a:bodyPr/>
          <a:lstStyle/>
          <a:p>
            <a:r>
              <a:rPr lang="en-US" dirty="0"/>
              <a:t>Duplications</a:t>
            </a:r>
          </a:p>
        </p:txBody>
      </p:sp>
      <p:pic>
        <p:nvPicPr>
          <p:cNvPr id="37" name="Picture 36" descr="Chart&#10;&#10;Description automatically generated">
            <a:extLst>
              <a:ext uri="{FF2B5EF4-FFF2-40B4-BE49-F238E27FC236}">
                <a16:creationId xmlns:a16="http://schemas.microsoft.com/office/drawing/2014/main" id="{3F5EA14D-FED8-4746-0DC1-CBFFA47FE34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90956" y="682752"/>
            <a:ext cx="6013716" cy="5742444"/>
          </a:xfrm>
          <a:prstGeom prst="rect">
            <a:avLst/>
          </a:prstGeom>
        </p:spPr>
      </p:pic>
      <p:sp>
        <p:nvSpPr>
          <p:cNvPr id="38" name="TextBox 37">
            <a:extLst>
              <a:ext uri="{FF2B5EF4-FFF2-40B4-BE49-F238E27FC236}">
                <a16:creationId xmlns:a16="http://schemas.microsoft.com/office/drawing/2014/main" id="{99F87D25-1979-F8F4-E981-6A2B6FB689C4}"/>
              </a:ext>
            </a:extLst>
          </p:cNvPr>
          <p:cNvSpPr txBox="1"/>
          <p:nvPr/>
        </p:nvSpPr>
        <p:spPr>
          <a:xfrm>
            <a:off x="987328" y="3429000"/>
            <a:ext cx="4550476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ementary figure 9. Synonymous exome </a:t>
            </a:r>
          </a:p>
          <a:p>
            <a:r>
              <a:rPr lang="en-US" dirty="0"/>
              <a:t>Duplication sequences of parental ME180 and </a:t>
            </a:r>
          </a:p>
          <a:p>
            <a:r>
              <a:rPr lang="en-US" dirty="0"/>
              <a:t>GAN edited clones</a:t>
            </a:r>
          </a:p>
        </p:txBody>
      </p:sp>
    </p:spTree>
    <p:extLst>
      <p:ext uri="{BB962C8B-B14F-4D97-AF65-F5344CB8AC3E}">
        <p14:creationId xmlns:p14="http://schemas.microsoft.com/office/powerpoint/2010/main" val="186550657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1</TotalTime>
  <Words>16</Words>
  <Application>Microsoft Office PowerPoint</Application>
  <PresentationFormat>Widescreen</PresentationFormat>
  <Paragraphs>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Duplications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rivatsan, Eri S. (he/him/his)</dc:creator>
  <cp:lastModifiedBy>Srivatsan, Eri S. (he/him/his)</cp:lastModifiedBy>
  <cp:revision>8</cp:revision>
  <dcterms:created xsi:type="dcterms:W3CDTF">2024-02-09T21:19:49Z</dcterms:created>
  <dcterms:modified xsi:type="dcterms:W3CDTF">2024-02-09T21:50:52Z</dcterms:modified>
</cp:coreProperties>
</file>